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315" r:id="rId2"/>
  </p:sldIdLst>
  <p:sldSz cx="9601200" cy="12801600" type="A3"/>
  <p:notesSz cx="6858000" cy="9144000"/>
  <p:defaultTextStyle>
    <a:defPPr>
      <a:defRPr lang="ja-JP"/>
    </a:defPPr>
    <a:lvl1pPr marL="0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178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357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536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714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5892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070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249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428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oru Hanamura" initials="TH" lastIdx="4" clrIdx="0">
    <p:extLst>
      <p:ext uri="{19B8F6BF-5375-455C-9EA6-DF929625EA0E}">
        <p15:presenceInfo xmlns:p15="http://schemas.microsoft.com/office/powerpoint/2012/main" userId="Toru Hanamura" providerId="None"/>
      </p:ext>
    </p:extLst>
  </p:cmAuthor>
  <p:cmAuthor id="2" name="Richer, Jennifer" initials="RJ" lastIdx="6" clrIdx="1">
    <p:extLst>
      <p:ext uri="{19B8F6BF-5375-455C-9EA6-DF929625EA0E}">
        <p15:presenceInfo xmlns:p15="http://schemas.microsoft.com/office/powerpoint/2012/main" userId="Richer, Jennifer" providerId="None"/>
      </p:ext>
    </p:extLst>
  </p:cmAuthor>
  <p:cmAuthor id="3" name="花村 徹" initials="花村" lastIdx="2" clrIdx="2">
    <p:extLst>
      <p:ext uri="{19B8F6BF-5375-455C-9EA6-DF929625EA0E}">
        <p15:presenceInfo xmlns:p15="http://schemas.microsoft.com/office/powerpoint/2012/main" userId="713ce747a82cdf4e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108"/>
    <p:restoredTop sz="92978" autoAdjust="0"/>
  </p:normalViewPr>
  <p:slideViewPr>
    <p:cSldViewPr snapToGrid="0" snapToObjects="1">
      <p:cViewPr>
        <p:scale>
          <a:sx n="66" d="100"/>
          <a:sy n="66" d="100"/>
        </p:scale>
        <p:origin x="3256" y="-104"/>
      </p:cViewPr>
      <p:guideLst/>
    </p:cSldViewPr>
  </p:slideViewPr>
  <p:notesTextViewPr>
    <p:cViewPr>
      <p:scale>
        <a:sx n="95" d="100"/>
        <a:sy n="95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882A602-B26C-764C-9708-93A17553678C}" type="datetimeFigureOut">
              <a:rPr kumimoji="1" lang="ja-JP" altLang="en-US" smtClean="0"/>
              <a:t>2021/7/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445F9A1-8BE5-B546-9533-9E59946FDE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707560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178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357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536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714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5892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070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249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428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2095078"/>
            <a:ext cx="8161020" cy="4456853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00150" y="6723804"/>
            <a:ext cx="7200900" cy="3090756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7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7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70859" y="681567"/>
            <a:ext cx="2070259" cy="10848764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0083" y="681567"/>
            <a:ext cx="6090761" cy="10848764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7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7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5082" y="3191514"/>
            <a:ext cx="8281035" cy="5325109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082" y="8567000"/>
            <a:ext cx="8281035" cy="28003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/>
                </a:solidFill>
              </a:defRPr>
            </a:lvl1pPr>
            <a:lvl2pPr marL="48006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96012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3pPr>
            <a:lvl4pPr marL="14401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4pPr>
            <a:lvl5pPr marL="192024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5pPr>
            <a:lvl6pPr marL="240030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6pPr>
            <a:lvl7pPr marL="288036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7pPr>
            <a:lvl8pPr marL="336042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8pPr>
            <a:lvl9pPr marL="38404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7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0083" y="3407833"/>
            <a:ext cx="4080510" cy="81224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60608" y="3407833"/>
            <a:ext cx="4080510" cy="81224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7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681570"/>
            <a:ext cx="8281035" cy="2474384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1334" y="3138171"/>
            <a:ext cx="4061757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1334" y="4676140"/>
            <a:ext cx="4061757" cy="68778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60608" y="3138171"/>
            <a:ext cx="4081761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60608" y="4676140"/>
            <a:ext cx="4081761" cy="68778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7/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7/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7/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81760" y="1843196"/>
            <a:ext cx="4860608" cy="9097433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7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81760" y="1843196"/>
            <a:ext cx="4860608" cy="9097433"/>
          </a:xfrm>
        </p:spPr>
        <p:txBody>
          <a:bodyPr anchor="t"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r>
              <a:rPr lang="ja-JP" altLang="en-US"/>
              <a:t>プレースホルダーまでドラッグするか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7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0083" y="681570"/>
            <a:ext cx="8281035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0083" y="3407833"/>
            <a:ext cx="8281035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BDA99A-FF6A-744E-AD7B-15F802665C1C}" type="datetimeFigureOut">
              <a:rPr kumimoji="1" lang="ja-JP" altLang="en-US" smtClean="0"/>
              <a:t>2021/7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80398" y="11865189"/>
            <a:ext cx="3240405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72336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60120" rtl="0" eaLnBrk="1" latinLnBrk="0" hangingPunct="1">
        <a:lnSpc>
          <a:spcPct val="90000"/>
        </a:lnSpc>
        <a:spcBef>
          <a:spcPct val="0"/>
        </a:spcBef>
        <a:buNone/>
        <a:defRPr kumimoji="1"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030" indent="-240030" algn="l" defTabSz="96012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kumimoji="1" sz="2940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 4">
            <a:extLst>
              <a:ext uri="{FF2B5EF4-FFF2-40B4-BE49-F238E27FC236}">
                <a16:creationId xmlns:a16="http://schemas.microsoft.com/office/drawing/2014/main" id="{F4B595FD-87C8-F14E-944A-586427220BF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8771810"/>
              </p:ext>
            </p:extLst>
          </p:nvPr>
        </p:nvGraphicFramePr>
        <p:xfrm>
          <a:off x="934763" y="1003688"/>
          <a:ext cx="7731673" cy="10195256"/>
        </p:xfrm>
        <a:graphic>
          <a:graphicData uri="http://schemas.openxmlformats.org/drawingml/2006/table">
            <a:tbl>
              <a:tblPr/>
              <a:tblGrid>
                <a:gridCol w="2704029">
                  <a:extLst>
                    <a:ext uri="{9D8B030D-6E8A-4147-A177-3AD203B41FA5}">
                      <a16:colId xmlns:a16="http://schemas.microsoft.com/office/drawing/2014/main" val="1386058298"/>
                    </a:ext>
                  </a:extLst>
                </a:gridCol>
                <a:gridCol w="1388000">
                  <a:extLst>
                    <a:ext uri="{9D8B030D-6E8A-4147-A177-3AD203B41FA5}">
                      <a16:colId xmlns:a16="http://schemas.microsoft.com/office/drawing/2014/main" val="3335817476"/>
                    </a:ext>
                  </a:extLst>
                </a:gridCol>
                <a:gridCol w="1984326">
                  <a:extLst>
                    <a:ext uri="{9D8B030D-6E8A-4147-A177-3AD203B41FA5}">
                      <a16:colId xmlns:a16="http://schemas.microsoft.com/office/drawing/2014/main" val="1834620380"/>
                    </a:ext>
                  </a:extLst>
                </a:gridCol>
                <a:gridCol w="1655318">
                  <a:extLst>
                    <a:ext uri="{9D8B030D-6E8A-4147-A177-3AD203B41FA5}">
                      <a16:colId xmlns:a16="http://schemas.microsoft.com/office/drawing/2014/main" val="2029582956"/>
                    </a:ext>
                  </a:extLst>
                </a:gridCol>
              </a:tblGrid>
              <a:tr h="176558">
                <a:tc gridSpan="4"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Supplementary table 4. Comparison of proliferative response to </a:t>
                      </a:r>
                      <a:r>
                        <a:rPr lang="en-US" sz="14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Enza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 between cell lines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79726167"/>
                  </a:ext>
                </a:extLst>
              </a:tr>
              <a:tr h="176558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Mixed-effect analysis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　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　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　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11146379"/>
                  </a:ext>
                </a:extLst>
              </a:tr>
              <a:tr h="176558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Fixed effects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P value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　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　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36260376"/>
                  </a:ext>
                </a:extLst>
              </a:tr>
              <a:tr h="176558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Cell lines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&lt;0.0001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3567398"/>
                  </a:ext>
                </a:extLst>
              </a:tr>
              <a:tr h="176558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Dose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&lt;0.0001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64558814"/>
                  </a:ext>
                </a:extLst>
              </a:tr>
              <a:tr h="176558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cell lines x Dose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&lt;0.0001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　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　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20258156"/>
                  </a:ext>
                </a:extLst>
              </a:tr>
              <a:tr h="176558">
                <a:tc>
                  <a:txBody>
                    <a:bodyPr/>
                    <a:lstStyle/>
                    <a:p>
                      <a:pPr algn="l" fontAlgn="b"/>
                      <a:r>
                        <a:rPr lang="ja-JP" alt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　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　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　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　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25950864"/>
                  </a:ext>
                </a:extLst>
              </a:tr>
              <a:tr h="176558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Mjultipole comperison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3324500"/>
                  </a:ext>
                </a:extLst>
              </a:tr>
              <a:tr h="176558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Tukey's multiple comparisons test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Mean Diff.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95.00% CI of diff.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Adjusted P Value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51582236"/>
                  </a:ext>
                </a:extLst>
              </a:tr>
              <a:tr h="176558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MDA-MB-453 vs. HCC2185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17.31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26.82 to -7.802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&lt;0.0001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64818675"/>
                  </a:ext>
                </a:extLst>
              </a:tr>
              <a:tr h="176558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MDA-MB-453 vs. BT-549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5393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5.150 to 6.228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&gt;0.9999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95087946"/>
                  </a:ext>
                </a:extLst>
              </a:tr>
              <a:tr h="176558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MDA-MB-453 vs. MDA-MB-468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4.704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15.89 to 6.482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8727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27102209"/>
                  </a:ext>
                </a:extLst>
              </a:tr>
              <a:tr h="176558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MDA-MB-453 vs. BT-474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14.05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27.79 to -0.3104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425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34305790"/>
                  </a:ext>
                </a:extLst>
              </a:tr>
              <a:tr h="176558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MDA-MB-453 vs. ZR-75-1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25.48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36.81 to -14.14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&lt;0.0001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34314435"/>
                  </a:ext>
                </a:extLst>
              </a:tr>
              <a:tr h="176558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MDA-MB-453 vs. SK-BR-3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14.83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24.65 to -5.002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009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51637051"/>
                  </a:ext>
                </a:extLst>
              </a:tr>
              <a:tr h="176558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MDA-MB-453 vs. MCF7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7.09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18.37 to 4.192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47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66389082"/>
                  </a:ext>
                </a:extLst>
              </a:tr>
              <a:tr h="176558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MDA-MB-453 vs. T-47D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5.318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14.06 to 3.420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5108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83815302"/>
                  </a:ext>
                </a:extLst>
              </a:tr>
              <a:tr h="176558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HCC2185 vs. BT-549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17.85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6.913 to 28.78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003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46378619"/>
                  </a:ext>
                </a:extLst>
              </a:tr>
              <a:tr h="176558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HCC2185 vs. MDA-MB-468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12.61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4.170 to 21.04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01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18227762"/>
                  </a:ext>
                </a:extLst>
              </a:tr>
              <a:tr h="176558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HCC2185 vs. BT-474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3.261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7.195 to 13.72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972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35255845"/>
                  </a:ext>
                </a:extLst>
              </a:tr>
              <a:tr h="176558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HCC2185 vs. ZR-75-1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8.166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15.30 to -1.032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168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30368814"/>
                  </a:ext>
                </a:extLst>
              </a:tr>
              <a:tr h="176558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HCC2185 vs. SK-BR-3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2.482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4.709 to 9.674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9535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66277855"/>
                  </a:ext>
                </a:extLst>
              </a:tr>
              <a:tr h="176558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HCC2185 vs. MCF7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10.22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3.552 to 23.99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2678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26289218"/>
                  </a:ext>
                </a:extLst>
              </a:tr>
              <a:tr h="176558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HCC2185 vs. T-47D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11.99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1.805 to 22.18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13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5906919"/>
                  </a:ext>
                </a:extLst>
              </a:tr>
              <a:tr h="176558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BT-549 vs. MDA-MB-468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5.243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17.24 to 6.758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8485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85216031"/>
                  </a:ext>
                </a:extLst>
              </a:tr>
              <a:tr h="176558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BT-549 vs. BT-474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14.59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27.04 to -2.141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14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02326058"/>
                  </a:ext>
                </a:extLst>
              </a:tr>
              <a:tr h="176558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BT-549 vs. ZR-75-1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26.01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36.78 to -15.25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&lt;0.0001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51006087"/>
                  </a:ext>
                </a:extLst>
              </a:tr>
              <a:tr h="176558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BT-549 vs. SK-BR-3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15.37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25.02 to -5.718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005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66744581"/>
                  </a:ext>
                </a:extLst>
              </a:tr>
              <a:tr h="176558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BT-549 vs. MCF7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7.629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15.31 to 0.05244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525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81887186"/>
                  </a:ext>
                </a:extLst>
              </a:tr>
              <a:tr h="176558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BT-549 vs. T-47D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5.858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11.43 to -0.2855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343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01141245"/>
                  </a:ext>
                </a:extLst>
              </a:tr>
              <a:tr h="176558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MDA-MB-468 vs. BT-474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9.346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22.54 to 3.853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3147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23468537"/>
                  </a:ext>
                </a:extLst>
              </a:tr>
              <a:tr h="176558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MDA-MB-468 vs. ZR-75-1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20.77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31.27 to -10.28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&lt;0.0001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79965597"/>
                  </a:ext>
                </a:extLst>
              </a:tr>
              <a:tr h="176558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MDA-MB-468 vs. SK-BR-3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10.12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20.77 to 0.5171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708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11970222"/>
                  </a:ext>
                </a:extLst>
              </a:tr>
              <a:tr h="176558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MDA-MB-468 vs. MCF7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2.386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16.34 to 11.57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9995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37383147"/>
                  </a:ext>
                </a:extLst>
              </a:tr>
              <a:tr h="176558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MDA-MB-468 vs. T-47D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6147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11.83 to 10.60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&gt;0.9999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49310193"/>
                  </a:ext>
                </a:extLst>
              </a:tr>
              <a:tr h="176558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BT-474 vs. ZR-75-1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11.43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20.93 to -1.925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111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49097672"/>
                  </a:ext>
                </a:extLst>
              </a:tr>
              <a:tr h="176558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BT-474 vs. SK-BR-3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7785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7.786 to 6.229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&gt;0.9999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46163229"/>
                  </a:ext>
                </a:extLst>
              </a:tr>
              <a:tr h="176558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BT-474 vs. MCF7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6.96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5.655 to 19.57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621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42089140"/>
                  </a:ext>
                </a:extLst>
              </a:tr>
              <a:tr h="176558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BT-474 vs. T-47D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8.731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1614 to 17.62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569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4884269"/>
                  </a:ext>
                </a:extLst>
              </a:tr>
              <a:tr h="176558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ZR-75-1 vs. SK-BR-3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10.65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3.618 to 17.68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009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61778338"/>
                  </a:ext>
                </a:extLst>
              </a:tr>
              <a:tr h="176558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ZR-75-1 vs. MCF7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18.39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7.226 to 29.55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003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3033796"/>
                  </a:ext>
                </a:extLst>
              </a:tr>
              <a:tr h="176558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ZR-75-1 vs. T-47D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20.16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11.13 to 29.18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&lt;0.0001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20752110"/>
                  </a:ext>
                </a:extLst>
              </a:tr>
              <a:tr h="176558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SK-BR-3 vs. MCF7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7.738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3.372 to 18.85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3412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4303736"/>
                  </a:ext>
                </a:extLst>
              </a:tr>
              <a:tr h="176558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SK-BR-3 vs. T-47D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9.51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2.213 to 16.81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048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02368142"/>
                  </a:ext>
                </a:extLst>
              </a:tr>
              <a:tr h="176558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MCF7 vs. T-47D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1.771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4.010 to 7.552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9765</a:t>
                      </a: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39216314"/>
                  </a:ext>
                </a:extLst>
              </a:tr>
              <a:tr h="176558">
                <a:tc>
                  <a:txBody>
                    <a:bodyPr/>
                    <a:lstStyle/>
                    <a:p>
                      <a:pPr algn="l" fontAlgn="b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8276" marR="8276" marT="827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9674081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003370492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ホワイ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ホワイ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ホワイ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919</TotalTime>
  <Words>454</Words>
  <Application>Microsoft Macintosh PowerPoint</Application>
  <PresentationFormat>A3 297x420 mm</PresentationFormat>
  <Paragraphs>17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Yu Gothic</vt:lpstr>
      <vt:lpstr>Arial</vt:lpstr>
      <vt:lpstr>Calibri</vt:lpstr>
      <vt:lpstr>Calibri Light</vt:lpstr>
      <vt:lpstr>ホワイト</vt:lpstr>
      <vt:lpstr>PowerPoint プレゼンテーション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subject/>
  <dc:creator>花村 徹</dc:creator>
  <cp:keywords/>
  <dc:description/>
  <cp:lastModifiedBy>花村 徹</cp:lastModifiedBy>
  <cp:revision>648</cp:revision>
  <cp:lastPrinted>2019-11-15T20:26:41Z</cp:lastPrinted>
  <dcterms:created xsi:type="dcterms:W3CDTF">2019-06-11T17:31:31Z</dcterms:created>
  <dcterms:modified xsi:type="dcterms:W3CDTF">2021-07-09T02:37:49Z</dcterms:modified>
  <cp:category/>
</cp:coreProperties>
</file>